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794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058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687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729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801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83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197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698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628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126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829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B7E87-3308-46F2-8563-64E125C547B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5FD94D-C169-4E10-9166-B673D6E81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667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2777" y="330926"/>
            <a:ext cx="9413422" cy="546989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992777" y="5892891"/>
            <a:ext cx="10406199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4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­) for benzylate chloroquinolines against sensitive strain 3D7. Compound 8d was removed from this analysis due to its inactivation of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ozo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formation, despite it had goo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effect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82203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5:56:26Z</dcterms:created>
  <dcterms:modified xsi:type="dcterms:W3CDTF">2020-08-04T16:31:03Z</dcterms:modified>
</cp:coreProperties>
</file>